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0" d="100"/>
          <a:sy n="70" d="100"/>
        </p:scale>
        <p:origin x="536" y="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1382A7-5668-C14C-A33C-D4FB210CCDB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D90749A-D111-1062-8DCE-B6558CE51E0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C12C48-D04D-85FC-321F-A3191310F2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A91F7-A834-406E-8355-CF17779FCD1E}" type="datetimeFigureOut">
              <a:rPr lang="en-US" smtClean="0"/>
              <a:t>2/16/2026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6B2539-A9B1-10C0-82C8-B338900EEF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7E9B0B-CCCA-7378-ABC2-F4FCA32049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57B0F-848C-43BC-9781-0AFE883CE9D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593732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A80F7C-4AB0-DFFC-6D13-07B872FBEA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E34BF04-0BA0-E56E-FAFB-66DE8C810B7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151129-4573-E781-0374-411A7A97F7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A91F7-A834-406E-8355-CF17779FCD1E}" type="datetimeFigureOut">
              <a:rPr lang="en-US" smtClean="0"/>
              <a:t>2/16/2026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AEB3F3-5F20-489D-C491-A500FDCF98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5E2186-6EE4-D318-CE4E-E561DAAE09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57B0F-848C-43BC-9781-0AFE883CE9D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363573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4F992F9-7504-1033-1840-597E77546DC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8D117C7-87F0-106B-BBB0-E42C4A498C8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BEBA2B-859F-BFA1-F4B0-6EA40575E8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A91F7-A834-406E-8355-CF17779FCD1E}" type="datetimeFigureOut">
              <a:rPr lang="en-US" smtClean="0"/>
              <a:t>2/16/2026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8C28E1-C50F-A1BA-FBE9-101224F843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8D9612-AB91-685B-A2AB-B762DD66B4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57B0F-848C-43BC-9781-0AFE883CE9D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866008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0F19D4-6A54-0476-90FC-47F507D526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55020B8-EA18-50D8-7EB2-C03077D340F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9B5B73-F709-8345-2055-22FA11E74F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A91F7-A834-406E-8355-CF17779FCD1E}" type="datetimeFigureOut">
              <a:rPr lang="en-US" smtClean="0"/>
              <a:t>2/16/2026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17800A-9C80-D431-FFE8-18A1A88E39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66DAEC-84EA-7DA5-38B3-3F1FBA6094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57B0F-848C-43BC-9781-0AFE883CE9D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801418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0549C0-7F7D-77DB-C17B-1231B55AA1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F8AC7BF-0A5F-A9F6-6707-A120BDC4F4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830AAE-1A89-E325-1E6D-F5081A4C9F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A91F7-A834-406E-8355-CF17779FCD1E}" type="datetimeFigureOut">
              <a:rPr lang="en-US" smtClean="0"/>
              <a:t>2/16/2026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9D09AEE-82BB-FBF9-4979-F2F749FD3E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203ED7-1D36-60EB-5B8B-FCCA07846C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57B0F-848C-43BC-9781-0AFE883CE9D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076953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BDDB70-E8AE-A3E6-70E1-5D41637F43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3B36C91-1984-7732-2048-79CE6030EB0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C91D220-0DE7-8042-9A83-04CE9F47E3F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3F61A21-F5BA-8419-411D-AB19B2C7ED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A91F7-A834-406E-8355-CF17779FCD1E}" type="datetimeFigureOut">
              <a:rPr lang="en-US" smtClean="0"/>
              <a:t>2/16/2026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81922B6-71FA-2DE0-C61F-2D92334856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AD9E73E-CCF3-7760-6A4E-FD74E6E447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57B0F-848C-43BC-9781-0AFE883CE9D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208749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F24D00-75A7-17C6-A1F5-A754F74F70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DDB6EC1-5FE2-830B-7DC2-C4312C90FE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0423EB0-DDB2-AF1D-0BA8-959C28D9451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0F41592-E93F-93A6-17B5-9628B2A1894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802C153-8988-E59A-1271-81AB2C0D48D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59FDB77-6BC0-3ACC-6D66-521EB84FFB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A91F7-A834-406E-8355-CF17779FCD1E}" type="datetimeFigureOut">
              <a:rPr lang="en-US" smtClean="0"/>
              <a:t>2/16/2026</a:t>
            </a:fld>
            <a:endParaRPr lang="en-US" dirty="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B0EECE3-5B59-FA31-A8EE-FDA803427C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FB24FC8-D763-BD5A-C7B3-AAA23CB5EB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57B0F-848C-43BC-9781-0AFE883CE9D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009059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E62EE1-87C1-5F1B-3D91-4BE2860F32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8BDC943-4D3F-3CA3-64B6-B2228C044A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A91F7-A834-406E-8355-CF17779FCD1E}" type="datetimeFigureOut">
              <a:rPr lang="en-US" smtClean="0"/>
              <a:t>2/16/2026</a:t>
            </a:fld>
            <a:endParaRPr lang="en-US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D1C9D35-1107-A978-014B-C192EDCC00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96443CF-FA64-3358-499B-8752AA7E2E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57B0F-848C-43BC-9781-0AFE883CE9D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128955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B7090C3-9315-0E7A-5BD8-22ABFAAA1F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A91F7-A834-406E-8355-CF17779FCD1E}" type="datetimeFigureOut">
              <a:rPr lang="en-US" smtClean="0"/>
              <a:t>2/16/2026</a:t>
            </a:fld>
            <a:endParaRPr lang="en-US" dirty="0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64CF1F7-BDD2-E03D-1B94-6085394454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CF4FF9B-52B3-898D-0881-03E309F070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57B0F-848C-43BC-9781-0AFE883CE9D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785166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CDAF98-A861-E3FA-FBCF-31FFF7DCE4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4025ADC-C940-44BC-515F-4E04335FBB5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DF2EF71-8F9E-EBE2-7271-44D12608218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C68DEC4-11AD-C27B-748E-57939C09BB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A91F7-A834-406E-8355-CF17779FCD1E}" type="datetimeFigureOut">
              <a:rPr lang="en-US" smtClean="0"/>
              <a:t>2/16/2026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A18123B-230A-5565-E7E1-F45F7B9555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AB64C94-800B-6AE7-2A07-95A2166CB2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57B0F-848C-43BC-9781-0AFE883CE9D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523058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3C4237-1C15-F9F5-40C0-FED06B25C6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6B112C4-084C-3252-EFCC-D580067F61C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CD57351-2E27-FDCF-5FD0-C30EF27AEFA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753CD35-B7C4-EC24-5E0C-FB910E7FD3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A91F7-A834-406E-8355-CF17779FCD1E}" type="datetimeFigureOut">
              <a:rPr lang="en-US" smtClean="0"/>
              <a:t>2/16/2026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40EE68A-8855-2C9D-2295-7FE33F22EC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A730805-47C9-7BBA-1BC6-FD733DF74C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57B0F-848C-43BC-9781-0AFE883CE9D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915548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3BA419E-1F36-245D-D6A5-05D63185D5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443CF50-E445-7CAF-8691-3E84F6C9D4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4B525BB-D604-2108-EE51-00E694BC81E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28A91F7-A834-406E-8355-CF17779FCD1E}" type="datetimeFigureOut">
              <a:rPr lang="en-US" smtClean="0"/>
              <a:t>2/16/2026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94E230-181A-EEBA-6BF2-DECDA2181C7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AA78FE-15F3-7F2B-3B93-E121C2E15B6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5D57B0F-848C-43BC-9781-0AFE883CE9D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557306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727CE59A-90B5-CC67-C68A-9ECA8F881A12}"/>
              </a:ext>
            </a:extLst>
          </p:cNvPr>
          <p:cNvGrpSpPr/>
          <p:nvPr/>
        </p:nvGrpSpPr>
        <p:grpSpPr>
          <a:xfrm>
            <a:off x="2477670" y="98740"/>
            <a:ext cx="7041234" cy="6912816"/>
            <a:chOff x="2477670" y="98740"/>
            <a:chExt cx="7041234" cy="6912816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BD8680F5-7A66-41C0-3095-BFE948DFCEA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477670" y="667680"/>
              <a:ext cx="7041234" cy="5522639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779480A9-F75A-E761-0550-8F732AF6B096}"/>
                </a:ext>
              </a:extLst>
            </p:cNvPr>
            <p:cNvSpPr txBox="1"/>
            <p:nvPr/>
          </p:nvSpPr>
          <p:spPr>
            <a:xfrm>
              <a:off x="2477670" y="98740"/>
              <a:ext cx="680920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Supplemental Figure. 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Adjudication and ICD-based reason for hospitalization agreement stratified by diagnosis category</a:t>
              </a:r>
              <a:endParaRPr 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916E7233-F87A-5DCA-7F34-B89F0776ADAA}"/>
                </a:ext>
              </a:extLst>
            </p:cNvPr>
            <p:cNvSpPr txBox="1"/>
            <p:nvPr/>
          </p:nvSpPr>
          <p:spPr>
            <a:xfrm>
              <a:off x="2477670" y="6226726"/>
              <a:ext cx="7041234" cy="7848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op diagnosis categories as determined by the ICD-based method, with overlaid results of adjudication. </a:t>
              </a:r>
              <a:r>
                <a: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Diagnosis category determined by modified Clinical Classifications Software applied to ICD-based reason for hospitalization, with reorganized infections and AIDS-defining illnesses.</a:t>
              </a:r>
            </a:p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ADI=AIDS-defining illness; GU=genitourinary; GI=gastrointestinal</a:t>
              </a:r>
            </a:p>
            <a:p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9478541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64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>UNC Healt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ommanday, Alexander</dc:creator>
  <cp:lastModifiedBy>Commanday, Alexander</cp:lastModifiedBy>
  <cp:revision>3</cp:revision>
  <dcterms:created xsi:type="dcterms:W3CDTF">2025-10-29T16:08:10Z</dcterms:created>
  <dcterms:modified xsi:type="dcterms:W3CDTF">2026-02-16T16:14:03Z</dcterms:modified>
</cp:coreProperties>
</file>